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5157A0-7F35-4247-8A88-1361D1DAFEF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DE5687-FD0F-4C2E-8540-78C7A9AA5F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285929-87E7-4A06-8C2D-158C2B6FB4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2EDAAA-A6EE-4904-9003-5B7A4BFFCA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D13E1B-B170-4541-8C5D-E14560D155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A32BA5-7319-40D4-B679-5274229E60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A33E78-1680-4F49-95B5-5A645E7C81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1F568F-9D27-4D81-BD9C-D3C3D34EC5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5F8CFA-7954-427A-B390-7CF97D368B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D179A4-5EC0-4612-B42E-9D5CD14F34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C8E48C-0D4C-402D-80FC-43F891E6AF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365C15-EC02-4EEA-9524-9EFA67ACD4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DC6477-BDF1-4903-A27B-15A33890A91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6"/>
          <p:cNvGrpSpPr/>
          <p:nvPr/>
        </p:nvGrpSpPr>
        <p:grpSpPr>
          <a:xfrm>
            <a:off x="380880" y="2971800"/>
            <a:ext cx="2057400" cy="1676520"/>
            <a:chOff x="380880" y="2971800"/>
            <a:chExt cx="2057400" cy="1676520"/>
          </a:xfrm>
        </p:grpSpPr>
        <p:pic>
          <p:nvPicPr>
            <p:cNvPr id="42" name="Picture 2" descr="bt20b.JPG"/>
            <p:cNvPicPr/>
            <p:nvPr/>
          </p:nvPicPr>
          <p:blipFill>
            <a:blip r:embed="rId1"/>
            <a:stretch/>
          </p:blipFill>
          <p:spPr>
            <a:xfrm>
              <a:off x="380880" y="2971800"/>
              <a:ext cx="2057400" cy="1676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 Box 5"/>
            <p:cNvSpPr/>
            <p:nvPr/>
          </p:nvSpPr>
          <p:spPr>
            <a:xfrm>
              <a:off x="990360" y="3181320"/>
              <a:ext cx="770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BT-2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" name="Group 9"/>
          <p:cNvGrpSpPr/>
          <p:nvPr/>
        </p:nvGrpSpPr>
        <p:grpSpPr>
          <a:xfrm>
            <a:off x="457200" y="1219320"/>
            <a:ext cx="2057400" cy="1676160"/>
            <a:chOff x="457200" y="1219320"/>
            <a:chExt cx="2057400" cy="1676160"/>
          </a:xfrm>
        </p:grpSpPr>
        <p:pic>
          <p:nvPicPr>
            <p:cNvPr id="45" name="Picture 2" descr="HCC1806c.JPG"/>
            <p:cNvPicPr/>
            <p:nvPr/>
          </p:nvPicPr>
          <p:blipFill>
            <a:blip r:embed="rId2"/>
            <a:stretch/>
          </p:blipFill>
          <p:spPr>
            <a:xfrm>
              <a:off x="457200" y="1219320"/>
              <a:ext cx="2057400" cy="1676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Box 6"/>
            <p:cNvSpPr/>
            <p:nvPr/>
          </p:nvSpPr>
          <p:spPr>
            <a:xfrm>
              <a:off x="928440" y="1382760"/>
              <a:ext cx="1177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HCC180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Group 7"/>
          <p:cNvGrpSpPr/>
          <p:nvPr/>
        </p:nvGrpSpPr>
        <p:grpSpPr>
          <a:xfrm>
            <a:off x="380880" y="4800600"/>
            <a:ext cx="2057400" cy="1676520"/>
            <a:chOff x="380880" y="4800600"/>
            <a:chExt cx="2057400" cy="1676520"/>
          </a:xfrm>
        </p:grpSpPr>
        <p:pic>
          <p:nvPicPr>
            <p:cNvPr id="48" name="Picture 3" descr="skbr3b.JPG"/>
            <p:cNvPicPr/>
            <p:nvPr/>
          </p:nvPicPr>
          <p:blipFill>
            <a:blip r:embed="rId3"/>
            <a:stretch/>
          </p:blipFill>
          <p:spPr>
            <a:xfrm>
              <a:off x="380880" y="4800600"/>
              <a:ext cx="2057400" cy="1676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TextBox 23"/>
            <p:cNvSpPr/>
            <p:nvPr/>
          </p:nvSpPr>
          <p:spPr>
            <a:xfrm>
              <a:off x="1068480" y="4952880"/>
              <a:ext cx="842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SKBR-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" name="Group 27"/>
          <p:cNvGrpSpPr/>
          <p:nvPr/>
        </p:nvGrpSpPr>
        <p:grpSpPr>
          <a:xfrm>
            <a:off x="2819520" y="1295280"/>
            <a:ext cx="1676160" cy="1600200"/>
            <a:chOff x="2819520" y="1295280"/>
            <a:chExt cx="1676160" cy="1600200"/>
          </a:xfrm>
        </p:grpSpPr>
        <p:pic>
          <p:nvPicPr>
            <p:cNvPr id="51" name="Picture 4" descr="05-06-11 MDA-MB-468 (hRS7)"/>
            <p:cNvPicPr/>
            <p:nvPr/>
          </p:nvPicPr>
          <p:blipFill>
            <a:blip r:embed="rId4"/>
            <a:stretch/>
          </p:blipFill>
          <p:spPr>
            <a:xfrm>
              <a:off x="2819520" y="1295280"/>
              <a:ext cx="1676160" cy="1600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Text Box 6"/>
            <p:cNvSpPr/>
            <p:nvPr/>
          </p:nvSpPr>
          <p:spPr>
            <a:xfrm>
              <a:off x="3110760" y="1490400"/>
              <a:ext cx="1276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DA-MB-46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" name="Group 28"/>
          <p:cNvGrpSpPr/>
          <p:nvPr/>
        </p:nvGrpSpPr>
        <p:grpSpPr>
          <a:xfrm>
            <a:off x="2819520" y="3048120"/>
            <a:ext cx="1752480" cy="1904760"/>
            <a:chOff x="2819520" y="3048120"/>
            <a:chExt cx="1752480" cy="1904760"/>
          </a:xfrm>
        </p:grpSpPr>
        <p:pic>
          <p:nvPicPr>
            <p:cNvPr id="54" name="Picture 2" descr="05-10-11 MCF7 (hRS7)"/>
            <p:cNvPicPr/>
            <p:nvPr/>
          </p:nvPicPr>
          <p:blipFill>
            <a:blip r:embed="rId5"/>
            <a:stretch/>
          </p:blipFill>
          <p:spPr>
            <a:xfrm>
              <a:off x="2819520" y="3048120"/>
              <a:ext cx="1752480" cy="1904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Text Box 5"/>
            <p:cNvSpPr/>
            <p:nvPr/>
          </p:nvSpPr>
          <p:spPr>
            <a:xfrm>
              <a:off x="3304800" y="3276720"/>
              <a:ext cx="723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F-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6" name="Group 26"/>
          <p:cNvGrpSpPr/>
          <p:nvPr/>
        </p:nvGrpSpPr>
        <p:grpSpPr>
          <a:xfrm>
            <a:off x="4800600" y="1295280"/>
            <a:ext cx="1905120" cy="1981440"/>
            <a:chOff x="4800600" y="1295280"/>
            <a:chExt cx="1905120" cy="1981440"/>
          </a:xfrm>
        </p:grpSpPr>
        <p:pic>
          <p:nvPicPr>
            <p:cNvPr id="57" name="Picture 3" descr="05-06-11 MDA-MB-231 (hRS7)"/>
            <p:cNvPicPr/>
            <p:nvPr/>
          </p:nvPicPr>
          <p:blipFill>
            <a:blip r:embed="rId6"/>
            <a:stretch/>
          </p:blipFill>
          <p:spPr>
            <a:xfrm>
              <a:off x="4800600" y="1295280"/>
              <a:ext cx="1815840" cy="1981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Text Box 7"/>
            <p:cNvSpPr/>
            <p:nvPr/>
          </p:nvSpPr>
          <p:spPr>
            <a:xfrm>
              <a:off x="5343480" y="1508040"/>
              <a:ext cx="1362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DA-MB-23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Group 8"/>
          <p:cNvGrpSpPr/>
          <p:nvPr/>
        </p:nvGrpSpPr>
        <p:grpSpPr>
          <a:xfrm>
            <a:off x="4876920" y="3733920"/>
            <a:ext cx="1946160" cy="1579320"/>
            <a:chOff x="4876920" y="3733920"/>
            <a:chExt cx="1946160" cy="1579320"/>
          </a:xfrm>
        </p:grpSpPr>
        <p:pic>
          <p:nvPicPr>
            <p:cNvPr id="60" name="Picture 1" descr="HCC1395b.JPG"/>
            <p:cNvPicPr/>
            <p:nvPr/>
          </p:nvPicPr>
          <p:blipFill>
            <a:blip r:embed="rId7"/>
            <a:stretch/>
          </p:blipFill>
          <p:spPr>
            <a:xfrm>
              <a:off x="4876920" y="3733920"/>
              <a:ext cx="1946160" cy="1579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TextBox 8"/>
            <p:cNvSpPr/>
            <p:nvPr/>
          </p:nvSpPr>
          <p:spPr>
            <a:xfrm>
              <a:off x="5481360" y="3930480"/>
              <a:ext cx="960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HCC139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2" name="Text Box 23"/>
          <p:cNvSpPr/>
          <p:nvPr/>
        </p:nvSpPr>
        <p:spPr>
          <a:xfrm>
            <a:off x="993240" y="838080"/>
            <a:ext cx="64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Hig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4"/>
          <p:cNvSpPr/>
          <p:nvPr/>
        </p:nvSpPr>
        <p:spPr>
          <a:xfrm>
            <a:off x="3050640" y="838080"/>
            <a:ext cx="99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Medi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25"/>
          <p:cNvSpPr/>
          <p:nvPr/>
        </p:nvSpPr>
        <p:spPr>
          <a:xfrm>
            <a:off x="5699160" y="569880"/>
            <a:ext cx="18396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7"/>
          <p:cNvSpPr/>
          <p:nvPr/>
        </p:nvSpPr>
        <p:spPr>
          <a:xfrm>
            <a:off x="5410080" y="762120"/>
            <a:ext cx="603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Low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28"/>
          <p:cNvSpPr/>
          <p:nvPr/>
        </p:nvSpPr>
        <p:spPr>
          <a:xfrm>
            <a:off x="5412960" y="3352680"/>
            <a:ext cx="108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gativ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29"/>
          <p:cNvSpPr/>
          <p:nvPr/>
        </p:nvSpPr>
        <p:spPr>
          <a:xfrm>
            <a:off x="3607920" y="6110280"/>
            <a:ext cx="194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lack: FITC-GA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30"/>
          <p:cNvSpPr/>
          <p:nvPr/>
        </p:nvSpPr>
        <p:spPr>
          <a:xfrm>
            <a:off x="3581280" y="5334120"/>
            <a:ext cx="2819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00"/>
                </a:solidFill>
                <a:latin typeface="Arial"/>
                <a:ea typeface="Arial"/>
              </a:rPr>
              <a:t>Red: hRS7 + FITC-GA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1"/>
          <p:cNvSpPr/>
          <p:nvPr/>
        </p:nvSpPr>
        <p:spPr>
          <a:xfrm>
            <a:off x="3581280" y="5715000"/>
            <a:ext cx="2819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cc66"/>
                </a:solidFill>
                <a:latin typeface="Arial"/>
                <a:ea typeface="Arial"/>
              </a:rPr>
              <a:t>Green: hA20 +FITC-GA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2"/>
          <p:cNvSpPr/>
          <p:nvPr/>
        </p:nvSpPr>
        <p:spPr>
          <a:xfrm>
            <a:off x="369720" y="112680"/>
            <a:ext cx="932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.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11T21:42:38Z</dcterms:created>
  <dc:creator>dliu</dc:creator>
  <dc:description/>
  <dc:language>en-US</dc:language>
  <cp:lastModifiedBy>Donglin Liu</cp:lastModifiedBy>
  <dcterms:modified xsi:type="dcterms:W3CDTF">2014-02-14T00:54:21Z</dcterms:modified>
  <cp:revision>85</cp:revision>
  <dc:subject/>
  <dc:title>Slide 1</dc:title>
</cp:coreProperties>
</file>